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40" r:id="rId2"/>
    <p:sldId id="343" r:id="rId3"/>
    <p:sldId id="342" r:id="rId4"/>
  </p:sldIdLst>
  <p:sldSz cx="6858000" cy="9906000" type="A4"/>
  <p:notesSz cx="6858000" cy="994568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1F0AE"/>
    <a:srgbClr val="CCFF66"/>
    <a:srgbClr val="00DA63"/>
    <a:srgbClr val="4923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35B8FCA-49A6-46C9-AE6A-5B54794FAC1B}" v="31" dt="2021-10-29T13:21:34.49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315" autoAdjust="0"/>
    <p:restoredTop sz="96374" autoAdjust="0"/>
  </p:normalViewPr>
  <p:slideViewPr>
    <p:cSldViewPr snapToGrid="0">
      <p:cViewPr>
        <p:scale>
          <a:sx n="75" d="100"/>
          <a:sy n="75" d="100"/>
        </p:scale>
        <p:origin x="2112" y="54"/>
      </p:cViewPr>
      <p:guideLst>
        <p:guide orient="horz" pos="3097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70" d="100"/>
        <a:sy n="170" d="100"/>
      </p:scale>
      <p:origin x="0" y="13062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rwan goy" userId="ab707ee1952ac8ac" providerId="LiveId" clId="{D35B8FCA-49A6-46C9-AE6A-5B54794FAC1B}"/>
    <pc:docChg chg="undo custSel addSld delSld modSld">
      <pc:chgData name="erwan goy" userId="ab707ee1952ac8ac" providerId="LiveId" clId="{D35B8FCA-49A6-46C9-AE6A-5B54794FAC1B}" dt="2021-10-29T13:21:39.547" v="90" actId="1076"/>
      <pc:docMkLst>
        <pc:docMk/>
      </pc:docMkLst>
      <pc:sldChg chg="addSp delSp modSp mod">
        <pc:chgData name="erwan goy" userId="ab707ee1952ac8ac" providerId="LiveId" clId="{D35B8FCA-49A6-46C9-AE6A-5B54794FAC1B}" dt="2021-10-29T13:21:30.550" v="88" actId="164"/>
        <pc:sldMkLst>
          <pc:docMk/>
          <pc:sldMk cId="1044720555" sldId="340"/>
        </pc:sldMkLst>
        <pc:spChg chg="mod">
          <ac:chgData name="erwan goy" userId="ab707ee1952ac8ac" providerId="LiveId" clId="{D35B8FCA-49A6-46C9-AE6A-5B54794FAC1B}" dt="2021-10-29T13:12:09.919" v="42" actId="1076"/>
          <ac:spMkLst>
            <pc:docMk/>
            <pc:sldMk cId="1044720555" sldId="340"/>
            <ac:spMk id="4" creationId="{118A8E69-933B-4861-A2DC-2D96577457B2}"/>
          </ac:spMkLst>
        </pc:spChg>
        <pc:spChg chg="mod">
          <ac:chgData name="erwan goy" userId="ab707ee1952ac8ac" providerId="LiveId" clId="{D35B8FCA-49A6-46C9-AE6A-5B54794FAC1B}" dt="2021-10-29T13:21:13.497" v="86" actId="1076"/>
          <ac:spMkLst>
            <pc:docMk/>
            <pc:sldMk cId="1044720555" sldId="340"/>
            <ac:spMk id="5" creationId="{2A03EB03-E791-49B9-8999-E9BB97C6B627}"/>
          </ac:spMkLst>
        </pc:spChg>
        <pc:spChg chg="mod">
          <ac:chgData name="erwan goy" userId="ab707ee1952ac8ac" providerId="LiveId" clId="{D35B8FCA-49A6-46C9-AE6A-5B54794FAC1B}" dt="2021-10-29T13:21:30.550" v="88" actId="164"/>
          <ac:spMkLst>
            <pc:docMk/>
            <pc:sldMk cId="1044720555" sldId="340"/>
            <ac:spMk id="8" creationId="{E0DF38A8-161C-4004-B745-EF548BB98EF2}"/>
          </ac:spMkLst>
        </pc:spChg>
        <pc:spChg chg="mod">
          <ac:chgData name="erwan goy" userId="ab707ee1952ac8ac" providerId="LiveId" clId="{D35B8FCA-49A6-46C9-AE6A-5B54794FAC1B}" dt="2021-10-29T13:21:30.550" v="88" actId="164"/>
          <ac:spMkLst>
            <pc:docMk/>
            <pc:sldMk cId="1044720555" sldId="340"/>
            <ac:spMk id="9" creationId="{D5F31F02-FDD6-4041-9E04-24DE432F0316}"/>
          </ac:spMkLst>
        </pc:spChg>
        <pc:spChg chg="del">
          <ac:chgData name="erwan goy" userId="ab707ee1952ac8ac" providerId="LiveId" clId="{D35B8FCA-49A6-46C9-AE6A-5B54794FAC1B}" dt="2021-10-29T13:11:32.249" v="37" actId="478"/>
          <ac:spMkLst>
            <pc:docMk/>
            <pc:sldMk cId="1044720555" sldId="340"/>
            <ac:spMk id="10" creationId="{78A2DE1F-FAE9-4CD6-9D64-C955B13C5AA4}"/>
          </ac:spMkLst>
        </pc:spChg>
        <pc:spChg chg="mod">
          <ac:chgData name="erwan goy" userId="ab707ee1952ac8ac" providerId="LiveId" clId="{D35B8FCA-49A6-46C9-AE6A-5B54794FAC1B}" dt="2021-10-29T13:11:13.894" v="33"/>
          <ac:spMkLst>
            <pc:docMk/>
            <pc:sldMk cId="1044720555" sldId="340"/>
            <ac:spMk id="32" creationId="{368F5D9A-7B41-4C7A-B672-E6D3366DBFE0}"/>
          </ac:spMkLst>
        </pc:spChg>
        <pc:spChg chg="mod">
          <ac:chgData name="erwan goy" userId="ab707ee1952ac8ac" providerId="LiveId" clId="{D35B8FCA-49A6-46C9-AE6A-5B54794FAC1B}" dt="2021-10-29T13:11:13.894" v="33"/>
          <ac:spMkLst>
            <pc:docMk/>
            <pc:sldMk cId="1044720555" sldId="340"/>
            <ac:spMk id="35" creationId="{7E88D5D5-006E-4999-BEC4-4DFE93A95FDD}"/>
          </ac:spMkLst>
        </pc:spChg>
        <pc:spChg chg="add del mod">
          <ac:chgData name="erwan goy" userId="ab707ee1952ac8ac" providerId="LiveId" clId="{D35B8FCA-49A6-46C9-AE6A-5B54794FAC1B}" dt="2021-10-29T13:12:42.769" v="50" actId="478"/>
          <ac:spMkLst>
            <pc:docMk/>
            <pc:sldMk cId="1044720555" sldId="340"/>
            <ac:spMk id="37" creationId="{5E371CC9-3671-480F-8897-416E4BFDF0A3}"/>
          </ac:spMkLst>
        </pc:spChg>
        <pc:spChg chg="add del mod">
          <ac:chgData name="erwan goy" userId="ab707ee1952ac8ac" providerId="LiveId" clId="{D35B8FCA-49A6-46C9-AE6A-5B54794FAC1B}" dt="2021-10-29T13:12:42.769" v="50" actId="478"/>
          <ac:spMkLst>
            <pc:docMk/>
            <pc:sldMk cId="1044720555" sldId="340"/>
            <ac:spMk id="38" creationId="{B56A5D75-C7C0-4FE4-A83D-91418DF7211C}"/>
          </ac:spMkLst>
        </pc:spChg>
        <pc:spChg chg="add del mod">
          <ac:chgData name="erwan goy" userId="ab707ee1952ac8ac" providerId="LiveId" clId="{D35B8FCA-49A6-46C9-AE6A-5B54794FAC1B}" dt="2021-10-29T13:12:42.769" v="50" actId="478"/>
          <ac:spMkLst>
            <pc:docMk/>
            <pc:sldMk cId="1044720555" sldId="340"/>
            <ac:spMk id="39" creationId="{3C8BC30C-41E6-4C05-B791-BDA6B28AB131}"/>
          </ac:spMkLst>
        </pc:spChg>
        <pc:spChg chg="add del mod">
          <ac:chgData name="erwan goy" userId="ab707ee1952ac8ac" providerId="LiveId" clId="{D35B8FCA-49A6-46C9-AE6A-5B54794FAC1B}" dt="2021-10-29T13:12:42.769" v="50" actId="478"/>
          <ac:spMkLst>
            <pc:docMk/>
            <pc:sldMk cId="1044720555" sldId="340"/>
            <ac:spMk id="40" creationId="{ABCCB0E0-BB42-49D8-8AC7-653A9C52B5FA}"/>
          </ac:spMkLst>
        </pc:spChg>
        <pc:spChg chg="add del mod">
          <ac:chgData name="erwan goy" userId="ab707ee1952ac8ac" providerId="LiveId" clId="{D35B8FCA-49A6-46C9-AE6A-5B54794FAC1B}" dt="2021-10-29T13:12:42.769" v="50" actId="478"/>
          <ac:spMkLst>
            <pc:docMk/>
            <pc:sldMk cId="1044720555" sldId="340"/>
            <ac:spMk id="41" creationId="{CC261945-9A15-4A20-8199-C41D253F2D90}"/>
          </ac:spMkLst>
        </pc:spChg>
        <pc:spChg chg="mod">
          <ac:chgData name="erwan goy" userId="ab707ee1952ac8ac" providerId="LiveId" clId="{D35B8FCA-49A6-46C9-AE6A-5B54794FAC1B}" dt="2021-10-29T13:12:09.919" v="42" actId="1076"/>
          <ac:spMkLst>
            <pc:docMk/>
            <pc:sldMk cId="1044720555" sldId="340"/>
            <ac:spMk id="50" creationId="{1E64ACF8-1B99-40CD-98E8-DFE9A7337A25}"/>
          </ac:spMkLst>
        </pc:spChg>
        <pc:spChg chg="del mod">
          <ac:chgData name="erwan goy" userId="ab707ee1952ac8ac" providerId="LiveId" clId="{D35B8FCA-49A6-46C9-AE6A-5B54794FAC1B}" dt="2021-10-29T13:19:23.547" v="74" actId="478"/>
          <ac:spMkLst>
            <pc:docMk/>
            <pc:sldMk cId="1044720555" sldId="340"/>
            <ac:spMk id="52" creationId="{00000000-0000-0000-0000-000000000000}"/>
          </ac:spMkLst>
        </pc:spChg>
        <pc:spChg chg="del mod">
          <ac:chgData name="erwan goy" userId="ab707ee1952ac8ac" providerId="LiveId" clId="{D35B8FCA-49A6-46C9-AE6A-5B54794FAC1B}" dt="2021-10-29T13:19:19.168" v="72" actId="478"/>
          <ac:spMkLst>
            <pc:docMk/>
            <pc:sldMk cId="1044720555" sldId="340"/>
            <ac:spMk id="54" creationId="{00000000-0000-0000-0000-000000000000}"/>
          </ac:spMkLst>
        </pc:spChg>
        <pc:spChg chg="del mod">
          <ac:chgData name="erwan goy" userId="ab707ee1952ac8ac" providerId="LiveId" clId="{D35B8FCA-49A6-46C9-AE6A-5B54794FAC1B}" dt="2021-10-29T13:19:19.168" v="72" actId="478"/>
          <ac:spMkLst>
            <pc:docMk/>
            <pc:sldMk cId="1044720555" sldId="340"/>
            <ac:spMk id="56" creationId="{00000000-0000-0000-0000-000000000000}"/>
          </ac:spMkLst>
        </pc:spChg>
        <pc:spChg chg="del mod">
          <ac:chgData name="erwan goy" userId="ab707ee1952ac8ac" providerId="LiveId" clId="{D35B8FCA-49A6-46C9-AE6A-5B54794FAC1B}" dt="2021-10-29T13:19:19.168" v="72" actId="478"/>
          <ac:spMkLst>
            <pc:docMk/>
            <pc:sldMk cId="1044720555" sldId="340"/>
            <ac:spMk id="58" creationId="{00000000-0000-0000-0000-000000000000}"/>
          </ac:spMkLst>
        </pc:spChg>
        <pc:spChg chg="del mod">
          <ac:chgData name="erwan goy" userId="ab707ee1952ac8ac" providerId="LiveId" clId="{D35B8FCA-49A6-46C9-AE6A-5B54794FAC1B}" dt="2021-10-29T13:19:19.168" v="72" actId="478"/>
          <ac:spMkLst>
            <pc:docMk/>
            <pc:sldMk cId="1044720555" sldId="340"/>
            <ac:spMk id="60" creationId="{00000000-0000-0000-0000-000000000000}"/>
          </ac:spMkLst>
        </pc:spChg>
        <pc:spChg chg="del">
          <ac:chgData name="erwan goy" userId="ab707ee1952ac8ac" providerId="LiveId" clId="{D35B8FCA-49A6-46C9-AE6A-5B54794FAC1B}" dt="2021-10-29T13:11:32.249" v="37" actId="478"/>
          <ac:spMkLst>
            <pc:docMk/>
            <pc:sldMk cId="1044720555" sldId="340"/>
            <ac:spMk id="73" creationId="{00000000-0000-0000-0000-000000000000}"/>
          </ac:spMkLst>
        </pc:spChg>
        <pc:spChg chg="mod">
          <ac:chgData name="erwan goy" userId="ab707ee1952ac8ac" providerId="LiveId" clId="{D35B8FCA-49A6-46C9-AE6A-5B54794FAC1B}" dt="2021-10-29T13:21:30.550" v="88" actId="164"/>
          <ac:spMkLst>
            <pc:docMk/>
            <pc:sldMk cId="1044720555" sldId="340"/>
            <ac:spMk id="76" creationId="{ACEDCA74-D73E-484D-BE9E-F05EA1D015B3}"/>
          </ac:spMkLst>
        </pc:spChg>
        <pc:spChg chg="mod">
          <ac:chgData name="erwan goy" userId="ab707ee1952ac8ac" providerId="LiveId" clId="{D35B8FCA-49A6-46C9-AE6A-5B54794FAC1B}" dt="2021-10-29T13:21:30.550" v="88" actId="164"/>
          <ac:spMkLst>
            <pc:docMk/>
            <pc:sldMk cId="1044720555" sldId="340"/>
            <ac:spMk id="77" creationId="{B30DAAEB-6CFB-4EA8-9336-4342082005BC}"/>
          </ac:spMkLst>
        </pc:spChg>
        <pc:spChg chg="mod">
          <ac:chgData name="erwan goy" userId="ab707ee1952ac8ac" providerId="LiveId" clId="{D35B8FCA-49A6-46C9-AE6A-5B54794FAC1B}" dt="2021-10-29T13:21:30.550" v="88" actId="164"/>
          <ac:spMkLst>
            <pc:docMk/>
            <pc:sldMk cId="1044720555" sldId="340"/>
            <ac:spMk id="78" creationId="{8A8BE1E9-3C9D-44AB-8FD2-9BD2E2407BFD}"/>
          </ac:spMkLst>
        </pc:spChg>
        <pc:grpChg chg="mod">
          <ac:chgData name="erwan goy" userId="ab707ee1952ac8ac" providerId="LiveId" clId="{D35B8FCA-49A6-46C9-AE6A-5B54794FAC1B}" dt="2021-10-29T13:21:30.550" v="88" actId="164"/>
          <ac:grpSpMkLst>
            <pc:docMk/>
            <pc:sldMk cId="1044720555" sldId="340"/>
            <ac:grpSpMk id="7" creationId="{B9B27557-9E41-4D0C-9F22-74D6659C1111}"/>
          </ac:grpSpMkLst>
        </pc:grpChg>
        <pc:grpChg chg="add mod">
          <ac:chgData name="erwan goy" userId="ab707ee1952ac8ac" providerId="LiveId" clId="{D35B8FCA-49A6-46C9-AE6A-5B54794FAC1B}" dt="2021-10-29T13:21:30.550" v="88" actId="164"/>
          <ac:grpSpMkLst>
            <pc:docMk/>
            <pc:sldMk cId="1044720555" sldId="340"/>
            <ac:grpSpMk id="13" creationId="{D28FCD9F-5593-448F-B468-64F131981B95}"/>
          </ac:grpSpMkLst>
        </pc:grpChg>
        <pc:grpChg chg="add del mod">
          <ac:chgData name="erwan goy" userId="ab707ee1952ac8ac" providerId="LiveId" clId="{D35B8FCA-49A6-46C9-AE6A-5B54794FAC1B}" dt="2021-10-29T13:12:42.769" v="50" actId="478"/>
          <ac:grpSpMkLst>
            <pc:docMk/>
            <pc:sldMk cId="1044720555" sldId="340"/>
            <ac:grpSpMk id="31" creationId="{3584A4EE-0C1C-4DE9-B03E-795088327FC2}"/>
          </ac:grpSpMkLst>
        </pc:grpChg>
        <pc:grpChg chg="add del mod">
          <ac:chgData name="erwan goy" userId="ab707ee1952ac8ac" providerId="LiveId" clId="{D35B8FCA-49A6-46C9-AE6A-5B54794FAC1B}" dt="2021-10-29T13:12:42.769" v="50" actId="478"/>
          <ac:grpSpMkLst>
            <pc:docMk/>
            <pc:sldMk cId="1044720555" sldId="340"/>
            <ac:grpSpMk id="34" creationId="{F0E30DEB-833A-45AC-9898-B6B600173F90}"/>
          </ac:grpSpMkLst>
        </pc:grpChg>
        <pc:grpChg chg="mod">
          <ac:chgData name="erwan goy" userId="ab707ee1952ac8ac" providerId="LiveId" clId="{D35B8FCA-49A6-46C9-AE6A-5B54794FAC1B}" dt="2021-10-29T13:21:30.550" v="88" actId="164"/>
          <ac:grpSpMkLst>
            <pc:docMk/>
            <pc:sldMk cId="1044720555" sldId="340"/>
            <ac:grpSpMk id="49" creationId="{EAD87416-1287-44D8-8728-979CEF8F0FE1}"/>
          </ac:grpSpMkLst>
        </pc:grpChg>
        <pc:picChg chg="add del mod modCrop">
          <ac:chgData name="erwan goy" userId="ab707ee1952ac8ac" providerId="LiveId" clId="{D35B8FCA-49A6-46C9-AE6A-5B54794FAC1B}" dt="2021-10-29T13:18:49.368" v="70" actId="478"/>
          <ac:picMkLst>
            <pc:docMk/>
            <pc:sldMk cId="1044720555" sldId="340"/>
            <ac:picMk id="3" creationId="{DFE92491-3871-4182-88C3-ED3169373F8A}"/>
          </ac:picMkLst>
        </pc:picChg>
        <pc:picChg chg="add mod ord">
          <ac:chgData name="erwan goy" userId="ab707ee1952ac8ac" providerId="LiveId" clId="{D35B8FCA-49A6-46C9-AE6A-5B54794FAC1B}" dt="2021-10-29T13:20:09.824" v="79" actId="167"/>
          <ac:picMkLst>
            <pc:docMk/>
            <pc:sldMk cId="1044720555" sldId="340"/>
            <ac:picMk id="12" creationId="{84F3D218-FABF-46DF-9123-956C687020A6}"/>
          </ac:picMkLst>
        </pc:picChg>
        <pc:picChg chg="del">
          <ac:chgData name="erwan goy" userId="ab707ee1952ac8ac" providerId="LiveId" clId="{D35B8FCA-49A6-46C9-AE6A-5B54794FAC1B}" dt="2021-10-29T13:10:53.139" v="28" actId="478"/>
          <ac:picMkLst>
            <pc:docMk/>
            <pc:sldMk cId="1044720555" sldId="340"/>
            <ac:picMk id="44" creationId="{00000000-0000-0000-0000-000000000000}"/>
          </ac:picMkLst>
        </pc:picChg>
        <pc:picChg chg="del mod">
          <ac:chgData name="erwan goy" userId="ab707ee1952ac8ac" providerId="LiveId" clId="{D35B8FCA-49A6-46C9-AE6A-5B54794FAC1B}" dt="2021-10-29T13:19:52.247" v="75" actId="478"/>
          <ac:picMkLst>
            <pc:docMk/>
            <pc:sldMk cId="1044720555" sldId="340"/>
            <ac:picMk id="71" creationId="{00000000-0000-0000-0000-000000000000}"/>
          </ac:picMkLst>
        </pc:picChg>
        <pc:picChg chg="del mod">
          <ac:chgData name="erwan goy" userId="ab707ee1952ac8ac" providerId="LiveId" clId="{D35B8FCA-49A6-46C9-AE6A-5B54794FAC1B}" dt="2021-10-29T13:21:08.487" v="85" actId="478"/>
          <ac:picMkLst>
            <pc:docMk/>
            <pc:sldMk cId="1044720555" sldId="340"/>
            <ac:picMk id="74" creationId="{00000000-0000-0000-0000-000000000000}"/>
          </ac:picMkLst>
        </pc:picChg>
        <pc:cxnChg chg="mod">
          <ac:chgData name="erwan goy" userId="ab707ee1952ac8ac" providerId="LiveId" clId="{D35B8FCA-49A6-46C9-AE6A-5B54794FAC1B}" dt="2021-10-29T13:12:09.919" v="42" actId="1076"/>
          <ac:cxnSpMkLst>
            <pc:docMk/>
            <pc:sldMk cId="1044720555" sldId="340"/>
            <ac:cxnSpMk id="6" creationId="{395A2BA7-91AE-4595-AD32-5974F514EC83}"/>
          </ac:cxnSpMkLst>
        </pc:cxnChg>
        <pc:cxnChg chg="mod">
          <ac:chgData name="erwan goy" userId="ab707ee1952ac8ac" providerId="LiveId" clId="{D35B8FCA-49A6-46C9-AE6A-5B54794FAC1B}" dt="2021-10-29T13:11:13.894" v="33"/>
          <ac:cxnSpMkLst>
            <pc:docMk/>
            <pc:sldMk cId="1044720555" sldId="340"/>
            <ac:cxnSpMk id="33" creationId="{019D8FB2-91AD-44AB-8EDF-531CEE014EE5}"/>
          </ac:cxnSpMkLst>
        </pc:cxnChg>
        <pc:cxnChg chg="mod">
          <ac:chgData name="erwan goy" userId="ab707ee1952ac8ac" providerId="LiveId" clId="{D35B8FCA-49A6-46C9-AE6A-5B54794FAC1B}" dt="2021-10-29T13:11:13.894" v="33"/>
          <ac:cxnSpMkLst>
            <pc:docMk/>
            <pc:sldMk cId="1044720555" sldId="340"/>
            <ac:cxnSpMk id="36" creationId="{23DFC719-B2C5-450A-BC50-34996912D909}"/>
          </ac:cxnSpMkLst>
        </pc:cxnChg>
        <pc:cxnChg chg="del mod">
          <ac:chgData name="erwan goy" userId="ab707ee1952ac8ac" providerId="LiveId" clId="{D35B8FCA-49A6-46C9-AE6A-5B54794FAC1B}" dt="2021-10-29T13:19:19.168" v="72" actId="478"/>
          <ac:cxnSpMkLst>
            <pc:docMk/>
            <pc:sldMk cId="1044720555" sldId="340"/>
            <ac:cxnSpMk id="51" creationId="{00000000-0000-0000-0000-000000000000}"/>
          </ac:cxnSpMkLst>
        </pc:cxnChg>
        <pc:cxnChg chg="del mod">
          <ac:chgData name="erwan goy" userId="ab707ee1952ac8ac" providerId="LiveId" clId="{D35B8FCA-49A6-46C9-AE6A-5B54794FAC1B}" dt="2021-10-29T13:19:19.168" v="72" actId="478"/>
          <ac:cxnSpMkLst>
            <pc:docMk/>
            <pc:sldMk cId="1044720555" sldId="340"/>
            <ac:cxnSpMk id="53" creationId="{00000000-0000-0000-0000-000000000000}"/>
          </ac:cxnSpMkLst>
        </pc:cxnChg>
        <pc:cxnChg chg="del mod">
          <ac:chgData name="erwan goy" userId="ab707ee1952ac8ac" providerId="LiveId" clId="{D35B8FCA-49A6-46C9-AE6A-5B54794FAC1B}" dt="2021-10-29T13:19:19.168" v="72" actId="478"/>
          <ac:cxnSpMkLst>
            <pc:docMk/>
            <pc:sldMk cId="1044720555" sldId="340"/>
            <ac:cxnSpMk id="55" creationId="{00000000-0000-0000-0000-000000000000}"/>
          </ac:cxnSpMkLst>
        </pc:cxnChg>
        <pc:cxnChg chg="del mod">
          <ac:chgData name="erwan goy" userId="ab707ee1952ac8ac" providerId="LiveId" clId="{D35B8FCA-49A6-46C9-AE6A-5B54794FAC1B}" dt="2021-10-29T13:19:19.168" v="72" actId="478"/>
          <ac:cxnSpMkLst>
            <pc:docMk/>
            <pc:sldMk cId="1044720555" sldId="340"/>
            <ac:cxnSpMk id="57" creationId="{00000000-0000-0000-0000-000000000000}"/>
          </ac:cxnSpMkLst>
        </pc:cxnChg>
        <pc:cxnChg chg="del mod">
          <ac:chgData name="erwan goy" userId="ab707ee1952ac8ac" providerId="LiveId" clId="{D35B8FCA-49A6-46C9-AE6A-5B54794FAC1B}" dt="2021-10-29T13:19:19.168" v="72" actId="478"/>
          <ac:cxnSpMkLst>
            <pc:docMk/>
            <pc:sldMk cId="1044720555" sldId="340"/>
            <ac:cxnSpMk id="59" creationId="{00000000-0000-0000-0000-000000000000}"/>
          </ac:cxnSpMkLst>
        </pc:cxnChg>
        <pc:cxnChg chg="mod">
          <ac:chgData name="erwan goy" userId="ab707ee1952ac8ac" providerId="LiveId" clId="{D35B8FCA-49A6-46C9-AE6A-5B54794FAC1B}" dt="2021-10-29T13:12:09.919" v="42" actId="1076"/>
          <ac:cxnSpMkLst>
            <pc:docMk/>
            <pc:sldMk cId="1044720555" sldId="340"/>
            <ac:cxnSpMk id="61" creationId="{3EE6D5E7-11FA-4FDF-B82C-70B65F95DC47}"/>
          </ac:cxnSpMkLst>
        </pc:cxnChg>
      </pc:sldChg>
      <pc:sldChg chg="modSp del">
        <pc:chgData name="erwan goy" userId="ab707ee1952ac8ac" providerId="LiveId" clId="{D35B8FCA-49A6-46C9-AE6A-5B54794FAC1B}" dt="2021-10-29T12:58:18.612" v="27" actId="47"/>
        <pc:sldMkLst>
          <pc:docMk/>
          <pc:sldMk cId="1665885389" sldId="341"/>
        </pc:sldMkLst>
        <pc:picChg chg="mod">
          <ac:chgData name="erwan goy" userId="ab707ee1952ac8ac" providerId="LiveId" clId="{D35B8FCA-49A6-46C9-AE6A-5B54794FAC1B}" dt="2021-10-29T12:36:39.779" v="0" actId="1076"/>
          <ac:picMkLst>
            <pc:docMk/>
            <pc:sldMk cId="1665885389" sldId="341"/>
            <ac:picMk id="62" creationId="{00000000-0000-0000-0000-000000000000}"/>
          </ac:picMkLst>
        </pc:picChg>
      </pc:sldChg>
      <pc:sldChg chg="addSp modSp new mod">
        <pc:chgData name="erwan goy" userId="ab707ee1952ac8ac" providerId="LiveId" clId="{D35B8FCA-49A6-46C9-AE6A-5B54794FAC1B}" dt="2021-10-29T12:58:16.081" v="26"/>
        <pc:sldMkLst>
          <pc:docMk/>
          <pc:sldMk cId="132352112" sldId="342"/>
        </pc:sldMkLst>
        <pc:spChg chg="mod">
          <ac:chgData name="erwan goy" userId="ab707ee1952ac8ac" providerId="LiveId" clId="{D35B8FCA-49A6-46C9-AE6A-5B54794FAC1B}" dt="2021-10-29T12:57:20.732" v="18"/>
          <ac:spMkLst>
            <pc:docMk/>
            <pc:sldMk cId="132352112" sldId="342"/>
            <ac:spMk id="5" creationId="{AFEDAC6E-FD71-4511-9044-38303E282B75}"/>
          </ac:spMkLst>
        </pc:spChg>
        <pc:spChg chg="mod">
          <ac:chgData name="erwan goy" userId="ab707ee1952ac8ac" providerId="LiveId" clId="{D35B8FCA-49A6-46C9-AE6A-5B54794FAC1B}" dt="2021-10-29T12:57:20.732" v="18"/>
          <ac:spMkLst>
            <pc:docMk/>
            <pc:sldMk cId="132352112" sldId="342"/>
            <ac:spMk id="8" creationId="{B3E13CED-BDB3-4C35-A5CD-ACF8684562CB}"/>
          </ac:spMkLst>
        </pc:spChg>
        <pc:spChg chg="add mod ord">
          <ac:chgData name="erwan goy" userId="ab707ee1952ac8ac" providerId="LiveId" clId="{D35B8FCA-49A6-46C9-AE6A-5B54794FAC1B}" dt="2021-10-29T12:57:28.944" v="20" actId="164"/>
          <ac:spMkLst>
            <pc:docMk/>
            <pc:sldMk cId="132352112" sldId="342"/>
            <ac:spMk id="10" creationId="{1FDBB48E-31BB-4A01-B3BC-5646099E1DF0}"/>
          </ac:spMkLst>
        </pc:spChg>
        <pc:spChg chg="add mod ord">
          <ac:chgData name="erwan goy" userId="ab707ee1952ac8ac" providerId="LiveId" clId="{D35B8FCA-49A6-46C9-AE6A-5B54794FAC1B}" dt="2021-10-29T12:57:28.944" v="20" actId="164"/>
          <ac:spMkLst>
            <pc:docMk/>
            <pc:sldMk cId="132352112" sldId="342"/>
            <ac:spMk id="11" creationId="{05A30CC0-63B9-4A6D-9677-8A68662B32E2}"/>
          </ac:spMkLst>
        </pc:spChg>
        <pc:spChg chg="add mod ord">
          <ac:chgData name="erwan goy" userId="ab707ee1952ac8ac" providerId="LiveId" clId="{D35B8FCA-49A6-46C9-AE6A-5B54794FAC1B}" dt="2021-10-29T12:57:28.944" v="20" actId="164"/>
          <ac:spMkLst>
            <pc:docMk/>
            <pc:sldMk cId="132352112" sldId="342"/>
            <ac:spMk id="12" creationId="{8FBE9A41-AC33-46F8-BC99-51C2FDEF4603}"/>
          </ac:spMkLst>
        </pc:spChg>
        <pc:spChg chg="add mod ord">
          <ac:chgData name="erwan goy" userId="ab707ee1952ac8ac" providerId="LiveId" clId="{D35B8FCA-49A6-46C9-AE6A-5B54794FAC1B}" dt="2021-10-29T12:57:28.944" v="20" actId="164"/>
          <ac:spMkLst>
            <pc:docMk/>
            <pc:sldMk cId="132352112" sldId="342"/>
            <ac:spMk id="13" creationId="{AC4A2170-BDEB-4CF6-A3FB-551349FB199F}"/>
          </ac:spMkLst>
        </pc:spChg>
        <pc:spChg chg="add mod ord">
          <ac:chgData name="erwan goy" userId="ab707ee1952ac8ac" providerId="LiveId" clId="{D35B8FCA-49A6-46C9-AE6A-5B54794FAC1B}" dt="2021-10-29T12:57:28.944" v="20" actId="164"/>
          <ac:spMkLst>
            <pc:docMk/>
            <pc:sldMk cId="132352112" sldId="342"/>
            <ac:spMk id="14" creationId="{7D1ACF77-8E03-4BD8-98AF-4A0C106772E1}"/>
          </ac:spMkLst>
        </pc:spChg>
        <pc:spChg chg="mod">
          <ac:chgData name="erwan goy" userId="ab707ee1952ac8ac" providerId="LiveId" clId="{D35B8FCA-49A6-46C9-AE6A-5B54794FAC1B}" dt="2021-10-29T12:57:50.041" v="24"/>
          <ac:spMkLst>
            <pc:docMk/>
            <pc:sldMk cId="132352112" sldId="342"/>
            <ac:spMk id="19" creationId="{251279B8-B0FA-4044-9416-3BFB2EEF9326}"/>
          </ac:spMkLst>
        </pc:spChg>
        <pc:spChg chg="mod">
          <ac:chgData name="erwan goy" userId="ab707ee1952ac8ac" providerId="LiveId" clId="{D35B8FCA-49A6-46C9-AE6A-5B54794FAC1B}" dt="2021-10-29T12:57:50.041" v="24"/>
          <ac:spMkLst>
            <pc:docMk/>
            <pc:sldMk cId="132352112" sldId="342"/>
            <ac:spMk id="20" creationId="{F13D1ECD-7228-4D64-AD6D-E35C5A95DAD8}"/>
          </ac:spMkLst>
        </pc:spChg>
        <pc:spChg chg="mod">
          <ac:chgData name="erwan goy" userId="ab707ee1952ac8ac" providerId="LiveId" clId="{D35B8FCA-49A6-46C9-AE6A-5B54794FAC1B}" dt="2021-10-29T12:57:50.041" v="24"/>
          <ac:spMkLst>
            <pc:docMk/>
            <pc:sldMk cId="132352112" sldId="342"/>
            <ac:spMk id="21" creationId="{56BA83BE-4CEA-4CF6-91F5-065F2B399A93}"/>
          </ac:spMkLst>
        </pc:spChg>
        <pc:spChg chg="mod">
          <ac:chgData name="erwan goy" userId="ab707ee1952ac8ac" providerId="LiveId" clId="{D35B8FCA-49A6-46C9-AE6A-5B54794FAC1B}" dt="2021-10-29T12:57:50.041" v="24"/>
          <ac:spMkLst>
            <pc:docMk/>
            <pc:sldMk cId="132352112" sldId="342"/>
            <ac:spMk id="22" creationId="{1D250535-9294-488F-9B34-CD9036A6DC08}"/>
          </ac:spMkLst>
        </pc:spChg>
        <pc:spChg chg="mod">
          <ac:chgData name="erwan goy" userId="ab707ee1952ac8ac" providerId="LiveId" clId="{D35B8FCA-49A6-46C9-AE6A-5B54794FAC1B}" dt="2021-10-29T12:57:50.041" v="24"/>
          <ac:spMkLst>
            <pc:docMk/>
            <pc:sldMk cId="132352112" sldId="342"/>
            <ac:spMk id="23" creationId="{9E6496FE-55F2-4D70-A7BE-93440C0442D8}"/>
          </ac:spMkLst>
        </pc:spChg>
        <pc:spChg chg="mod">
          <ac:chgData name="erwan goy" userId="ab707ee1952ac8ac" providerId="LiveId" clId="{D35B8FCA-49A6-46C9-AE6A-5B54794FAC1B}" dt="2021-10-29T12:57:50.041" v="24"/>
          <ac:spMkLst>
            <pc:docMk/>
            <pc:sldMk cId="132352112" sldId="342"/>
            <ac:spMk id="24" creationId="{95B98E74-3CEE-40FD-B6F1-A415D31CA5FB}"/>
          </ac:spMkLst>
        </pc:spChg>
        <pc:spChg chg="mod">
          <ac:chgData name="erwan goy" userId="ab707ee1952ac8ac" providerId="LiveId" clId="{D35B8FCA-49A6-46C9-AE6A-5B54794FAC1B}" dt="2021-10-29T12:57:50.041" v="24"/>
          <ac:spMkLst>
            <pc:docMk/>
            <pc:sldMk cId="132352112" sldId="342"/>
            <ac:spMk id="26" creationId="{BA6EE3DE-BB50-4789-BCC0-37C19420CD7B}"/>
          </ac:spMkLst>
        </pc:spChg>
        <pc:spChg chg="add mod">
          <ac:chgData name="erwan goy" userId="ab707ee1952ac8ac" providerId="LiveId" clId="{D35B8FCA-49A6-46C9-AE6A-5B54794FAC1B}" dt="2021-10-29T12:58:16.081" v="26"/>
          <ac:spMkLst>
            <pc:docMk/>
            <pc:sldMk cId="132352112" sldId="342"/>
            <ac:spMk id="28" creationId="{B8D6530E-1CA6-48DD-9301-37530A3513DE}"/>
          </ac:spMkLst>
        </pc:spChg>
        <pc:grpChg chg="add mod ord">
          <ac:chgData name="erwan goy" userId="ab707ee1952ac8ac" providerId="LiveId" clId="{D35B8FCA-49A6-46C9-AE6A-5B54794FAC1B}" dt="2021-10-29T12:57:28.944" v="20" actId="164"/>
          <ac:grpSpMkLst>
            <pc:docMk/>
            <pc:sldMk cId="132352112" sldId="342"/>
            <ac:grpSpMk id="4" creationId="{9CB49D03-58B6-484B-9703-4662E1B5667D}"/>
          </ac:grpSpMkLst>
        </pc:grpChg>
        <pc:grpChg chg="add mod ord">
          <ac:chgData name="erwan goy" userId="ab707ee1952ac8ac" providerId="LiveId" clId="{D35B8FCA-49A6-46C9-AE6A-5B54794FAC1B}" dt="2021-10-29T12:57:28.944" v="20" actId="164"/>
          <ac:grpSpMkLst>
            <pc:docMk/>
            <pc:sldMk cId="132352112" sldId="342"/>
            <ac:grpSpMk id="7" creationId="{6CC61F81-6DBF-437C-AB04-400E920A7A46}"/>
          </ac:grpSpMkLst>
        </pc:grpChg>
        <pc:grpChg chg="add mod">
          <ac:chgData name="erwan goy" userId="ab707ee1952ac8ac" providerId="LiveId" clId="{D35B8FCA-49A6-46C9-AE6A-5B54794FAC1B}" dt="2021-10-29T12:57:48.422" v="23" actId="1076"/>
          <ac:grpSpMkLst>
            <pc:docMk/>
            <pc:sldMk cId="132352112" sldId="342"/>
            <ac:grpSpMk id="15" creationId="{F67674B1-074A-4D70-8699-44B2DC35911B}"/>
          </ac:grpSpMkLst>
        </pc:grpChg>
        <pc:grpChg chg="add mod">
          <ac:chgData name="erwan goy" userId="ab707ee1952ac8ac" providerId="LiveId" clId="{D35B8FCA-49A6-46C9-AE6A-5B54794FAC1B}" dt="2021-10-29T12:57:54.883" v="25" actId="1076"/>
          <ac:grpSpMkLst>
            <pc:docMk/>
            <pc:sldMk cId="132352112" sldId="342"/>
            <ac:grpSpMk id="16" creationId="{19F4310E-26BA-4A69-A6DA-91294A696586}"/>
          </ac:grpSpMkLst>
        </pc:grpChg>
        <pc:grpChg chg="mod">
          <ac:chgData name="erwan goy" userId="ab707ee1952ac8ac" providerId="LiveId" clId="{D35B8FCA-49A6-46C9-AE6A-5B54794FAC1B}" dt="2021-10-29T12:57:50.041" v="24"/>
          <ac:grpSpMkLst>
            <pc:docMk/>
            <pc:sldMk cId="132352112" sldId="342"/>
            <ac:grpSpMk id="17" creationId="{8A0DA907-1060-4B85-B812-F7750DE92F7B}"/>
          </ac:grpSpMkLst>
        </pc:grpChg>
        <pc:grpChg chg="mod">
          <ac:chgData name="erwan goy" userId="ab707ee1952ac8ac" providerId="LiveId" clId="{D35B8FCA-49A6-46C9-AE6A-5B54794FAC1B}" dt="2021-10-29T12:57:50.041" v="24"/>
          <ac:grpSpMkLst>
            <pc:docMk/>
            <pc:sldMk cId="132352112" sldId="342"/>
            <ac:grpSpMk id="18" creationId="{A35CA07C-48C9-433B-9339-B4C682134D80}"/>
          </ac:grpSpMkLst>
        </pc:grpChg>
        <pc:picChg chg="add mod modCrop">
          <ac:chgData name="erwan goy" userId="ab707ee1952ac8ac" providerId="LiveId" clId="{D35B8FCA-49A6-46C9-AE6A-5B54794FAC1B}" dt="2021-10-29T12:57:38.711" v="22" actId="14100"/>
          <ac:picMkLst>
            <pc:docMk/>
            <pc:sldMk cId="132352112" sldId="342"/>
            <ac:picMk id="3" creationId="{14C7C596-C2A1-452E-8C92-D90147BF23FA}"/>
          </ac:picMkLst>
        </pc:picChg>
        <pc:cxnChg chg="mod">
          <ac:chgData name="erwan goy" userId="ab707ee1952ac8ac" providerId="LiveId" clId="{D35B8FCA-49A6-46C9-AE6A-5B54794FAC1B}" dt="2021-10-29T12:57:20.732" v="18"/>
          <ac:cxnSpMkLst>
            <pc:docMk/>
            <pc:sldMk cId="132352112" sldId="342"/>
            <ac:cxnSpMk id="6" creationId="{6EE8D359-B4A3-4B1A-9F3D-66134DCE42A1}"/>
          </ac:cxnSpMkLst>
        </pc:cxnChg>
        <pc:cxnChg chg="mod">
          <ac:chgData name="erwan goy" userId="ab707ee1952ac8ac" providerId="LiveId" clId="{D35B8FCA-49A6-46C9-AE6A-5B54794FAC1B}" dt="2021-10-29T12:57:20.732" v="18"/>
          <ac:cxnSpMkLst>
            <pc:docMk/>
            <pc:sldMk cId="132352112" sldId="342"/>
            <ac:cxnSpMk id="9" creationId="{0DBE8B86-1FDF-4F32-9C46-FA9152350FEC}"/>
          </ac:cxnSpMkLst>
        </pc:cxnChg>
        <pc:cxnChg chg="mod">
          <ac:chgData name="erwan goy" userId="ab707ee1952ac8ac" providerId="LiveId" clId="{D35B8FCA-49A6-46C9-AE6A-5B54794FAC1B}" dt="2021-10-29T12:57:50.041" v="24"/>
          <ac:cxnSpMkLst>
            <pc:docMk/>
            <pc:sldMk cId="132352112" sldId="342"/>
            <ac:cxnSpMk id="25" creationId="{FBCF7861-D3B4-435A-A9F9-805B95C6C6ED}"/>
          </ac:cxnSpMkLst>
        </pc:cxnChg>
        <pc:cxnChg chg="mod">
          <ac:chgData name="erwan goy" userId="ab707ee1952ac8ac" providerId="LiveId" clId="{D35B8FCA-49A6-46C9-AE6A-5B54794FAC1B}" dt="2021-10-29T12:57:50.041" v="24"/>
          <ac:cxnSpMkLst>
            <pc:docMk/>
            <pc:sldMk cId="132352112" sldId="342"/>
            <ac:cxnSpMk id="27" creationId="{51B4FE4E-1523-480E-A076-740B58CC5A68}"/>
          </ac:cxnSpMkLst>
        </pc:cxnChg>
      </pc:sldChg>
      <pc:sldChg chg="modSp add del mod">
        <pc:chgData name="erwan goy" userId="ab707ee1952ac8ac" providerId="LiveId" clId="{D35B8FCA-49A6-46C9-AE6A-5B54794FAC1B}" dt="2021-10-29T12:56:32.191" v="13" actId="47"/>
        <pc:sldMkLst>
          <pc:docMk/>
          <pc:sldMk cId="2444582298" sldId="343"/>
        </pc:sldMkLst>
        <pc:picChg chg="mod modCrop">
          <ac:chgData name="erwan goy" userId="ab707ee1952ac8ac" providerId="LiveId" clId="{D35B8FCA-49A6-46C9-AE6A-5B54794FAC1B}" dt="2021-10-29T12:55:09.112" v="12" actId="732"/>
          <ac:picMkLst>
            <pc:docMk/>
            <pc:sldMk cId="2444582298" sldId="343"/>
            <ac:picMk id="3" creationId="{14C7C596-C2A1-452E-8C92-D90147BF23FA}"/>
          </ac:picMkLst>
        </pc:picChg>
      </pc:sldChg>
      <pc:sldChg chg="addSp modSp new mod">
        <pc:chgData name="erwan goy" userId="ab707ee1952ac8ac" providerId="LiveId" clId="{D35B8FCA-49A6-46C9-AE6A-5B54794FAC1B}" dt="2021-10-29T13:21:39.547" v="90" actId="1076"/>
        <pc:sldMkLst>
          <pc:docMk/>
          <pc:sldMk cId="4095256110" sldId="343"/>
        </pc:sldMkLst>
        <pc:spChg chg="add mod">
          <ac:chgData name="erwan goy" userId="ab707ee1952ac8ac" providerId="LiveId" clId="{D35B8FCA-49A6-46C9-AE6A-5B54794FAC1B}" dt="2021-10-29T13:21:17.467" v="87"/>
          <ac:spMkLst>
            <pc:docMk/>
            <pc:sldMk cId="4095256110" sldId="343"/>
            <ac:spMk id="3" creationId="{280F880F-37B6-4ED6-8365-825A17D9C18A}"/>
          </ac:spMkLst>
        </pc:spChg>
        <pc:spChg chg="mod">
          <ac:chgData name="erwan goy" userId="ab707ee1952ac8ac" providerId="LiveId" clId="{D35B8FCA-49A6-46C9-AE6A-5B54794FAC1B}" dt="2021-10-29T13:21:34.497" v="89"/>
          <ac:spMkLst>
            <pc:docMk/>
            <pc:sldMk cId="4095256110" sldId="343"/>
            <ac:spMk id="7" creationId="{371CB9FB-F580-48EC-B3DF-0A6BCCF4D4CC}"/>
          </ac:spMkLst>
        </pc:spChg>
        <pc:spChg chg="mod">
          <ac:chgData name="erwan goy" userId="ab707ee1952ac8ac" providerId="LiveId" clId="{D35B8FCA-49A6-46C9-AE6A-5B54794FAC1B}" dt="2021-10-29T13:21:34.497" v="89"/>
          <ac:spMkLst>
            <pc:docMk/>
            <pc:sldMk cId="4095256110" sldId="343"/>
            <ac:spMk id="8" creationId="{3347D938-3298-4280-B704-64015DFFCD4E}"/>
          </ac:spMkLst>
        </pc:spChg>
        <pc:spChg chg="mod">
          <ac:chgData name="erwan goy" userId="ab707ee1952ac8ac" providerId="LiveId" clId="{D35B8FCA-49A6-46C9-AE6A-5B54794FAC1B}" dt="2021-10-29T13:21:34.497" v="89"/>
          <ac:spMkLst>
            <pc:docMk/>
            <pc:sldMk cId="4095256110" sldId="343"/>
            <ac:spMk id="9" creationId="{7A512C66-3DDB-424C-AF73-BECB6F4390CB}"/>
          </ac:spMkLst>
        </pc:spChg>
        <pc:spChg chg="mod">
          <ac:chgData name="erwan goy" userId="ab707ee1952ac8ac" providerId="LiveId" clId="{D35B8FCA-49A6-46C9-AE6A-5B54794FAC1B}" dt="2021-10-29T13:21:34.497" v="89"/>
          <ac:spMkLst>
            <pc:docMk/>
            <pc:sldMk cId="4095256110" sldId="343"/>
            <ac:spMk id="10" creationId="{F5196B64-382B-43FB-BD2F-C532C33726B8}"/>
          </ac:spMkLst>
        </pc:spChg>
        <pc:spChg chg="mod">
          <ac:chgData name="erwan goy" userId="ab707ee1952ac8ac" providerId="LiveId" clId="{D35B8FCA-49A6-46C9-AE6A-5B54794FAC1B}" dt="2021-10-29T13:21:34.497" v="89"/>
          <ac:spMkLst>
            <pc:docMk/>
            <pc:sldMk cId="4095256110" sldId="343"/>
            <ac:spMk id="11" creationId="{76D6F6F7-1673-4E6F-B1BA-41C2CB5ACA76}"/>
          </ac:spMkLst>
        </pc:spChg>
        <pc:spChg chg="mod">
          <ac:chgData name="erwan goy" userId="ab707ee1952ac8ac" providerId="LiveId" clId="{D35B8FCA-49A6-46C9-AE6A-5B54794FAC1B}" dt="2021-10-29T13:21:34.497" v="89"/>
          <ac:spMkLst>
            <pc:docMk/>
            <pc:sldMk cId="4095256110" sldId="343"/>
            <ac:spMk id="12" creationId="{8A391A9B-E3D6-4013-8E9A-F3B056E2741B}"/>
          </ac:spMkLst>
        </pc:spChg>
        <pc:spChg chg="mod">
          <ac:chgData name="erwan goy" userId="ab707ee1952ac8ac" providerId="LiveId" clId="{D35B8FCA-49A6-46C9-AE6A-5B54794FAC1B}" dt="2021-10-29T13:21:34.497" v="89"/>
          <ac:spMkLst>
            <pc:docMk/>
            <pc:sldMk cId="4095256110" sldId="343"/>
            <ac:spMk id="14" creationId="{3E49E84B-DA07-4998-B0D2-68B934398ADB}"/>
          </ac:spMkLst>
        </pc:spChg>
        <pc:grpChg chg="add mod">
          <ac:chgData name="erwan goy" userId="ab707ee1952ac8ac" providerId="LiveId" clId="{D35B8FCA-49A6-46C9-AE6A-5B54794FAC1B}" dt="2021-10-29T13:21:39.547" v="90" actId="1076"/>
          <ac:grpSpMkLst>
            <pc:docMk/>
            <pc:sldMk cId="4095256110" sldId="343"/>
            <ac:grpSpMk id="4" creationId="{D27055F7-5AEC-4ED3-A43A-EEF289AF1774}"/>
          </ac:grpSpMkLst>
        </pc:grpChg>
        <pc:grpChg chg="mod">
          <ac:chgData name="erwan goy" userId="ab707ee1952ac8ac" providerId="LiveId" clId="{D35B8FCA-49A6-46C9-AE6A-5B54794FAC1B}" dt="2021-10-29T13:21:34.497" v="89"/>
          <ac:grpSpMkLst>
            <pc:docMk/>
            <pc:sldMk cId="4095256110" sldId="343"/>
            <ac:grpSpMk id="5" creationId="{6C10F3A2-DA47-4FA7-8249-008C0FABB4BC}"/>
          </ac:grpSpMkLst>
        </pc:grpChg>
        <pc:grpChg chg="mod">
          <ac:chgData name="erwan goy" userId="ab707ee1952ac8ac" providerId="LiveId" clId="{D35B8FCA-49A6-46C9-AE6A-5B54794FAC1B}" dt="2021-10-29T13:21:34.497" v="89"/>
          <ac:grpSpMkLst>
            <pc:docMk/>
            <pc:sldMk cId="4095256110" sldId="343"/>
            <ac:grpSpMk id="6" creationId="{59E66A6B-D5E8-4C80-85B6-428676CBD18C}"/>
          </ac:grpSpMkLst>
        </pc:grpChg>
        <pc:picChg chg="add mod">
          <ac:chgData name="erwan goy" userId="ab707ee1952ac8ac" providerId="LiveId" clId="{D35B8FCA-49A6-46C9-AE6A-5B54794FAC1B}" dt="2021-10-29T13:21:05.107" v="84" actId="1076"/>
          <ac:picMkLst>
            <pc:docMk/>
            <pc:sldMk cId="4095256110" sldId="343"/>
            <ac:picMk id="2" creationId="{E9D23690-0772-424B-BBD7-95A9B4CAF838}"/>
          </ac:picMkLst>
        </pc:picChg>
        <pc:cxnChg chg="mod">
          <ac:chgData name="erwan goy" userId="ab707ee1952ac8ac" providerId="LiveId" clId="{D35B8FCA-49A6-46C9-AE6A-5B54794FAC1B}" dt="2021-10-29T13:21:34.497" v="89"/>
          <ac:cxnSpMkLst>
            <pc:docMk/>
            <pc:sldMk cId="4095256110" sldId="343"/>
            <ac:cxnSpMk id="13" creationId="{F8A8C3D1-0C77-4E7C-B909-2A3ED1714C11}"/>
          </ac:cxnSpMkLst>
        </pc:cxnChg>
        <pc:cxnChg chg="mod">
          <ac:chgData name="erwan goy" userId="ab707ee1952ac8ac" providerId="LiveId" clId="{D35B8FCA-49A6-46C9-AE6A-5B54794FAC1B}" dt="2021-10-29T13:21:34.497" v="89"/>
          <ac:cxnSpMkLst>
            <pc:docMk/>
            <pc:sldMk cId="4095256110" sldId="343"/>
            <ac:cxnSpMk id="15" creationId="{B34F0B4D-D6E2-4917-AD42-A97E773F544E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2547" cy="497842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3852" y="0"/>
            <a:ext cx="2972547" cy="497842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r">
              <a:defRPr sz="1200"/>
            </a:lvl1pPr>
          </a:lstStyle>
          <a:p>
            <a:fld id="{E70DE9C2-A804-4C0A-8835-7EF0AE63AFB9}" type="datetimeFigureOut">
              <a:rPr lang="en-US" smtClean="0"/>
              <a:t>10/29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70" tIns="45935" rIns="91870" bIns="45935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480" y="4723924"/>
            <a:ext cx="5487041" cy="4475798"/>
          </a:xfrm>
          <a:prstGeom prst="rect">
            <a:avLst/>
          </a:prstGeom>
        </p:spPr>
        <p:txBody>
          <a:bodyPr vert="horz" lIns="91870" tIns="45935" rIns="91870" bIns="45935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46257"/>
            <a:ext cx="2972547" cy="497841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3852" y="9446257"/>
            <a:ext cx="2972547" cy="497841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r">
              <a:defRPr sz="1200"/>
            </a:lvl1pPr>
          </a:lstStyle>
          <a:p>
            <a:fld id="{D2A2E8B2-22EA-423E-991B-A854B00339D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0447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5115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9698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8595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9493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2129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2597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404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9701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1538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4646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2811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4DDC8-1816-44B7-8A72-0DE68C7E7302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3737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 11" descr="Une image contenant texte, enveloppe, stationnaire&#10;&#10;Description générée automatiquement">
            <a:extLst>
              <a:ext uri="{FF2B5EF4-FFF2-40B4-BE49-F238E27FC236}">
                <a16:creationId xmlns:a16="http://schemas.microsoft.com/office/drawing/2014/main" id="{84F3D218-FABF-46DF-9123-956C687020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3029"/>
            <a:ext cx="6858000" cy="9699942"/>
          </a:xfrm>
          <a:prstGeom prst="rect">
            <a:avLst/>
          </a:prstGeom>
        </p:spPr>
      </p:pic>
      <p:grpSp>
        <p:nvGrpSpPr>
          <p:cNvPr id="13" name="Groupe 12">
            <a:extLst>
              <a:ext uri="{FF2B5EF4-FFF2-40B4-BE49-F238E27FC236}">
                <a16:creationId xmlns:a16="http://schemas.microsoft.com/office/drawing/2014/main" id="{D28FCD9F-5593-448F-B468-64F131981B95}"/>
              </a:ext>
            </a:extLst>
          </p:cNvPr>
          <p:cNvGrpSpPr/>
          <p:nvPr/>
        </p:nvGrpSpPr>
        <p:grpSpPr>
          <a:xfrm>
            <a:off x="1234407" y="103029"/>
            <a:ext cx="2009685" cy="626341"/>
            <a:chOff x="1234407" y="103029"/>
            <a:chExt cx="2009685" cy="626341"/>
          </a:xfrm>
        </p:grpSpPr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B9B27557-9E41-4D0C-9F22-74D6659C1111}"/>
                </a:ext>
              </a:extLst>
            </p:cNvPr>
            <p:cNvGrpSpPr/>
            <p:nvPr/>
          </p:nvGrpSpPr>
          <p:grpSpPr>
            <a:xfrm>
              <a:off x="1588751" y="115555"/>
              <a:ext cx="966740" cy="276999"/>
              <a:chOff x="1074491" y="5394686"/>
              <a:chExt cx="966740" cy="276997"/>
            </a:xfrm>
          </p:grpSpPr>
          <p:sp>
            <p:nvSpPr>
              <p:cNvPr id="4" name="ZoneTexte 3">
                <a:extLst>
                  <a:ext uri="{FF2B5EF4-FFF2-40B4-BE49-F238E27FC236}">
                    <a16:creationId xmlns:a16="http://schemas.microsoft.com/office/drawing/2014/main" id="{118A8E69-933B-4861-A2DC-2D96577457B2}"/>
                  </a:ext>
                </a:extLst>
              </p:cNvPr>
              <p:cNvSpPr txBox="1"/>
              <p:nvPr/>
            </p:nvSpPr>
            <p:spPr>
              <a:xfrm>
                <a:off x="1074491" y="5394686"/>
                <a:ext cx="966740" cy="276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Non-treated</a:t>
                </a:r>
              </a:p>
            </p:txBody>
          </p:sp>
          <p:cxnSp>
            <p:nvCxnSpPr>
              <p:cNvPr id="6" name="Connecteur droit 5">
                <a:extLst>
                  <a:ext uri="{FF2B5EF4-FFF2-40B4-BE49-F238E27FC236}">
                    <a16:creationId xmlns:a16="http://schemas.microsoft.com/office/drawing/2014/main" id="{395A2BA7-91AE-4595-AD32-5974F514EC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3294" y="5614953"/>
                <a:ext cx="57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Groupe 48">
              <a:extLst>
                <a:ext uri="{FF2B5EF4-FFF2-40B4-BE49-F238E27FC236}">
                  <a16:creationId xmlns:a16="http://schemas.microsoft.com/office/drawing/2014/main" id="{EAD87416-1287-44D8-8728-979CEF8F0FE1}"/>
                </a:ext>
              </a:extLst>
            </p:cNvPr>
            <p:cNvGrpSpPr/>
            <p:nvPr/>
          </p:nvGrpSpPr>
          <p:grpSpPr>
            <a:xfrm>
              <a:off x="2487025" y="103029"/>
              <a:ext cx="757067" cy="276999"/>
              <a:chOff x="1122619" y="5394686"/>
              <a:chExt cx="757067" cy="276997"/>
            </a:xfrm>
          </p:grpSpPr>
          <p:sp>
            <p:nvSpPr>
              <p:cNvPr id="50" name="ZoneTexte 49">
                <a:extLst>
                  <a:ext uri="{FF2B5EF4-FFF2-40B4-BE49-F238E27FC236}">
                    <a16:creationId xmlns:a16="http://schemas.microsoft.com/office/drawing/2014/main" id="{1E64ACF8-1B99-40CD-98E8-DFE9A7337A25}"/>
                  </a:ext>
                </a:extLst>
              </p:cNvPr>
              <p:cNvSpPr txBox="1"/>
              <p:nvPr/>
            </p:nvSpPr>
            <p:spPr>
              <a:xfrm>
                <a:off x="1122619" y="5394686"/>
                <a:ext cx="757067" cy="276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Veliparib</a:t>
                </a:r>
              </a:p>
            </p:txBody>
          </p:sp>
          <p:cxnSp>
            <p:nvCxnSpPr>
              <p:cNvPr id="61" name="Connecteur droit 60">
                <a:extLst>
                  <a:ext uri="{FF2B5EF4-FFF2-40B4-BE49-F238E27FC236}">
                    <a16:creationId xmlns:a16="http://schemas.microsoft.com/office/drawing/2014/main" id="{3EE6D5E7-11FA-4FDF-B82C-70B65F95DC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3294" y="5614953"/>
                <a:ext cx="57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E0DF38A8-161C-4004-B745-EF548BB98EF2}"/>
                </a:ext>
              </a:extLst>
            </p:cNvPr>
            <p:cNvSpPr txBox="1"/>
            <p:nvPr/>
          </p:nvSpPr>
          <p:spPr>
            <a:xfrm>
              <a:off x="1782690" y="360038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id="{ACEDCA74-D73E-484D-BE9E-F05EA1D015B3}"/>
                </a:ext>
              </a:extLst>
            </p:cNvPr>
            <p:cNvSpPr txBox="1"/>
            <p:nvPr/>
          </p:nvSpPr>
          <p:spPr>
            <a:xfrm>
              <a:off x="2145092" y="34932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+</a:t>
              </a:r>
            </a:p>
          </p:txBody>
        </p:sp>
        <p:sp>
          <p:nvSpPr>
            <p:cNvPr id="77" name="ZoneTexte 76">
              <a:extLst>
                <a:ext uri="{FF2B5EF4-FFF2-40B4-BE49-F238E27FC236}">
                  <a16:creationId xmlns:a16="http://schemas.microsoft.com/office/drawing/2014/main" id="{B30DAAEB-6CFB-4EA8-9336-4342082005BC}"/>
                </a:ext>
              </a:extLst>
            </p:cNvPr>
            <p:cNvSpPr txBox="1"/>
            <p:nvPr/>
          </p:nvSpPr>
          <p:spPr>
            <a:xfrm>
              <a:off x="2545480" y="351071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8A8BE1E9-3C9D-44AB-8FD2-9BD2E2407BFD}"/>
                </a:ext>
              </a:extLst>
            </p:cNvPr>
            <p:cNvSpPr txBox="1"/>
            <p:nvPr/>
          </p:nvSpPr>
          <p:spPr>
            <a:xfrm>
              <a:off x="2907882" y="34035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+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D5F31F02-FDD6-4041-9E04-24DE432F0316}"/>
                </a:ext>
              </a:extLst>
            </p:cNvPr>
            <p:cNvSpPr txBox="1"/>
            <p:nvPr/>
          </p:nvSpPr>
          <p:spPr>
            <a:xfrm>
              <a:off x="1234407" y="392554"/>
              <a:ext cx="4892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H</a:t>
              </a:r>
              <a:r>
                <a:rPr lang="en-GB" sz="1200" b="1" baseline="-25000" dirty="0"/>
                <a:t>2</a:t>
              </a:r>
              <a:r>
                <a:rPr lang="en-GB" sz="1200" b="1" dirty="0"/>
                <a:t>O</a:t>
              </a:r>
              <a:r>
                <a:rPr lang="en-GB" sz="1200" b="1" baseline="-25000" dirty="0"/>
                <a:t>2</a:t>
              </a:r>
            </a:p>
          </p:txBody>
        </p:sp>
      </p:grpSp>
      <p:sp>
        <p:nvSpPr>
          <p:cNvPr id="5" name="Rectangle 4">
            <a:extLst>
              <a:ext uri="{FF2B5EF4-FFF2-40B4-BE49-F238E27FC236}">
                <a16:creationId xmlns:a16="http://schemas.microsoft.com/office/drawing/2014/main" id="{2A03EB03-E791-49B9-8999-E9BB97C6B627}"/>
              </a:ext>
            </a:extLst>
          </p:cNvPr>
          <p:cNvSpPr/>
          <p:nvPr/>
        </p:nvSpPr>
        <p:spPr>
          <a:xfrm>
            <a:off x="4117576" y="79530"/>
            <a:ext cx="285941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7 – Figure supplement 4 – source data xx</a:t>
            </a:r>
            <a:endParaRPr lang="fr-FR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47205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C:\Users\egoy\Desktop\expérience NHDF ABT888 H2O2 5µM\western blot\sénescence\SPetunia15120417490.tif">
            <a:extLst>
              <a:ext uri="{FF2B5EF4-FFF2-40B4-BE49-F238E27FC236}">
                <a16:creationId xmlns:a16="http://schemas.microsoft.com/office/drawing/2014/main" id="{E9D23690-0772-424B-BBD7-95A9B4CAF83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223" t="11594" r="22062" b="48551"/>
          <a:stretch/>
        </p:blipFill>
        <p:spPr bwMode="auto">
          <a:xfrm>
            <a:off x="281138" y="3208096"/>
            <a:ext cx="6295723" cy="6036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80F880F-37B6-4ED6-8365-825A17D9C18A}"/>
              </a:ext>
            </a:extLst>
          </p:cNvPr>
          <p:cNvSpPr/>
          <p:nvPr/>
        </p:nvSpPr>
        <p:spPr>
          <a:xfrm>
            <a:off x="4117576" y="79530"/>
            <a:ext cx="285941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7 – Figure supplement 4 – source data xx</a:t>
            </a:r>
            <a:endParaRPr lang="fr-FR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" name="Groupe 3">
            <a:extLst>
              <a:ext uri="{FF2B5EF4-FFF2-40B4-BE49-F238E27FC236}">
                <a16:creationId xmlns:a16="http://schemas.microsoft.com/office/drawing/2014/main" id="{D27055F7-5AEC-4ED3-A43A-EEF289AF1774}"/>
              </a:ext>
            </a:extLst>
          </p:cNvPr>
          <p:cNvGrpSpPr/>
          <p:nvPr/>
        </p:nvGrpSpPr>
        <p:grpSpPr>
          <a:xfrm>
            <a:off x="2424156" y="2581755"/>
            <a:ext cx="2009685" cy="626341"/>
            <a:chOff x="1234407" y="103029"/>
            <a:chExt cx="2009685" cy="626341"/>
          </a:xfrm>
        </p:grpSpPr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6C10F3A2-DA47-4FA7-8249-008C0FABB4BC}"/>
                </a:ext>
              </a:extLst>
            </p:cNvPr>
            <p:cNvGrpSpPr/>
            <p:nvPr/>
          </p:nvGrpSpPr>
          <p:grpSpPr>
            <a:xfrm>
              <a:off x="1588751" y="115555"/>
              <a:ext cx="966740" cy="276999"/>
              <a:chOff x="1074491" y="5394686"/>
              <a:chExt cx="966740" cy="276997"/>
            </a:xfrm>
          </p:grpSpPr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3E49E84B-DA07-4998-B0D2-68B934398ADB}"/>
                  </a:ext>
                </a:extLst>
              </p:cNvPr>
              <p:cNvSpPr txBox="1"/>
              <p:nvPr/>
            </p:nvSpPr>
            <p:spPr>
              <a:xfrm>
                <a:off x="1074491" y="5394686"/>
                <a:ext cx="966740" cy="276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Non-treated</a:t>
                </a:r>
              </a:p>
            </p:txBody>
          </p:sp>
          <p:cxnSp>
            <p:nvCxnSpPr>
              <p:cNvPr id="15" name="Connecteur droit 14">
                <a:extLst>
                  <a:ext uri="{FF2B5EF4-FFF2-40B4-BE49-F238E27FC236}">
                    <a16:creationId xmlns:a16="http://schemas.microsoft.com/office/drawing/2014/main" id="{B34F0B4D-D6E2-4917-AD42-A97E773F54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3294" y="5614953"/>
                <a:ext cx="57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e 5">
              <a:extLst>
                <a:ext uri="{FF2B5EF4-FFF2-40B4-BE49-F238E27FC236}">
                  <a16:creationId xmlns:a16="http://schemas.microsoft.com/office/drawing/2014/main" id="{59E66A6B-D5E8-4C80-85B6-428676CBD18C}"/>
                </a:ext>
              </a:extLst>
            </p:cNvPr>
            <p:cNvGrpSpPr/>
            <p:nvPr/>
          </p:nvGrpSpPr>
          <p:grpSpPr>
            <a:xfrm>
              <a:off x="2487025" y="103029"/>
              <a:ext cx="757067" cy="276999"/>
              <a:chOff x="1122619" y="5394686"/>
              <a:chExt cx="757067" cy="276997"/>
            </a:xfrm>
          </p:grpSpPr>
          <p:sp>
            <p:nvSpPr>
              <p:cNvPr id="12" name="ZoneTexte 11">
                <a:extLst>
                  <a:ext uri="{FF2B5EF4-FFF2-40B4-BE49-F238E27FC236}">
                    <a16:creationId xmlns:a16="http://schemas.microsoft.com/office/drawing/2014/main" id="{8A391A9B-E3D6-4013-8E9A-F3B056E2741B}"/>
                  </a:ext>
                </a:extLst>
              </p:cNvPr>
              <p:cNvSpPr txBox="1"/>
              <p:nvPr/>
            </p:nvSpPr>
            <p:spPr>
              <a:xfrm>
                <a:off x="1122619" y="5394686"/>
                <a:ext cx="757067" cy="276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Veliparib</a:t>
                </a:r>
              </a:p>
            </p:txBody>
          </p:sp>
          <p:cxnSp>
            <p:nvCxnSpPr>
              <p:cNvPr id="13" name="Connecteur droit 12">
                <a:extLst>
                  <a:ext uri="{FF2B5EF4-FFF2-40B4-BE49-F238E27FC236}">
                    <a16:creationId xmlns:a16="http://schemas.microsoft.com/office/drawing/2014/main" id="{F8A8C3D1-0C77-4E7C-B909-2A3ED1714C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3294" y="5614953"/>
                <a:ext cx="57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371CB9FB-F580-48EC-B3DF-0A6BCCF4D4CC}"/>
                </a:ext>
              </a:extLst>
            </p:cNvPr>
            <p:cNvSpPr txBox="1"/>
            <p:nvPr/>
          </p:nvSpPr>
          <p:spPr>
            <a:xfrm>
              <a:off x="1782690" y="360038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3347D938-3298-4280-B704-64015DFFCD4E}"/>
                </a:ext>
              </a:extLst>
            </p:cNvPr>
            <p:cNvSpPr txBox="1"/>
            <p:nvPr/>
          </p:nvSpPr>
          <p:spPr>
            <a:xfrm>
              <a:off x="2145092" y="34932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+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7A512C66-3DDB-424C-AF73-BECB6F4390CB}"/>
                </a:ext>
              </a:extLst>
            </p:cNvPr>
            <p:cNvSpPr txBox="1"/>
            <p:nvPr/>
          </p:nvSpPr>
          <p:spPr>
            <a:xfrm>
              <a:off x="2545480" y="351071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F5196B64-382B-43FB-BD2F-C532C33726B8}"/>
                </a:ext>
              </a:extLst>
            </p:cNvPr>
            <p:cNvSpPr txBox="1"/>
            <p:nvPr/>
          </p:nvSpPr>
          <p:spPr>
            <a:xfrm>
              <a:off x="2907882" y="34035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+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76D6F6F7-1673-4E6F-B1BA-41C2CB5ACA76}"/>
                </a:ext>
              </a:extLst>
            </p:cNvPr>
            <p:cNvSpPr txBox="1"/>
            <p:nvPr/>
          </p:nvSpPr>
          <p:spPr>
            <a:xfrm>
              <a:off x="1234407" y="392554"/>
              <a:ext cx="4892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H</a:t>
              </a:r>
              <a:r>
                <a:rPr lang="en-GB" sz="1200" b="1" baseline="-25000" dirty="0"/>
                <a:t>2</a:t>
              </a:r>
              <a:r>
                <a:rPr lang="en-GB" sz="1200" b="1" dirty="0"/>
                <a:t>O</a:t>
              </a:r>
              <a:r>
                <a:rPr lang="en-GB" sz="1200" b="1" baseline="-25000" dirty="0"/>
                <a:t>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95256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iel&#10;&#10;Description générée automatiquement">
            <a:extLst>
              <a:ext uri="{FF2B5EF4-FFF2-40B4-BE49-F238E27FC236}">
                <a16:creationId xmlns:a16="http://schemas.microsoft.com/office/drawing/2014/main" id="{14C7C596-C2A1-452E-8C92-D90147BF23F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2350"/>
          <a:stretch/>
        </p:blipFill>
        <p:spPr>
          <a:xfrm rot="16200000">
            <a:off x="629799" y="1443741"/>
            <a:ext cx="5234092" cy="7222309"/>
          </a:xfrm>
          <a:prstGeom prst="rect">
            <a:avLst/>
          </a:prstGeom>
        </p:spPr>
      </p:pic>
      <p:grpSp>
        <p:nvGrpSpPr>
          <p:cNvPr id="15" name="Groupe 14">
            <a:extLst>
              <a:ext uri="{FF2B5EF4-FFF2-40B4-BE49-F238E27FC236}">
                <a16:creationId xmlns:a16="http://schemas.microsoft.com/office/drawing/2014/main" id="{F67674B1-074A-4D70-8699-44B2DC35911B}"/>
              </a:ext>
            </a:extLst>
          </p:cNvPr>
          <p:cNvGrpSpPr/>
          <p:nvPr/>
        </p:nvGrpSpPr>
        <p:grpSpPr>
          <a:xfrm>
            <a:off x="309558" y="3082934"/>
            <a:ext cx="2009685" cy="626341"/>
            <a:chOff x="595308" y="1273184"/>
            <a:chExt cx="2009685" cy="626341"/>
          </a:xfrm>
        </p:grpSpPr>
        <p:grpSp>
          <p:nvGrpSpPr>
            <p:cNvPr id="4" name="Groupe 3">
              <a:extLst>
                <a:ext uri="{FF2B5EF4-FFF2-40B4-BE49-F238E27FC236}">
                  <a16:creationId xmlns:a16="http://schemas.microsoft.com/office/drawing/2014/main" id="{9CB49D03-58B6-484B-9703-4662E1B5667D}"/>
                </a:ext>
              </a:extLst>
            </p:cNvPr>
            <p:cNvGrpSpPr/>
            <p:nvPr/>
          </p:nvGrpSpPr>
          <p:grpSpPr>
            <a:xfrm>
              <a:off x="949652" y="1285710"/>
              <a:ext cx="966740" cy="276999"/>
              <a:chOff x="1074491" y="5394686"/>
              <a:chExt cx="966740" cy="276997"/>
            </a:xfrm>
          </p:grpSpPr>
          <p:sp>
            <p:nvSpPr>
              <p:cNvPr id="5" name="ZoneTexte 4">
                <a:extLst>
                  <a:ext uri="{FF2B5EF4-FFF2-40B4-BE49-F238E27FC236}">
                    <a16:creationId xmlns:a16="http://schemas.microsoft.com/office/drawing/2014/main" id="{AFEDAC6E-FD71-4511-9044-38303E282B75}"/>
                  </a:ext>
                </a:extLst>
              </p:cNvPr>
              <p:cNvSpPr txBox="1"/>
              <p:nvPr/>
            </p:nvSpPr>
            <p:spPr>
              <a:xfrm>
                <a:off x="1074491" y="5394686"/>
                <a:ext cx="966740" cy="276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Non-treated</a:t>
                </a:r>
              </a:p>
            </p:txBody>
          </p:sp>
          <p:cxnSp>
            <p:nvCxnSpPr>
              <p:cNvPr id="6" name="Connecteur droit 5">
                <a:extLst>
                  <a:ext uri="{FF2B5EF4-FFF2-40B4-BE49-F238E27FC236}">
                    <a16:creationId xmlns:a16="http://schemas.microsoft.com/office/drawing/2014/main" id="{6EE8D359-B4A3-4B1A-9F3D-66134DCE42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3294" y="5614953"/>
                <a:ext cx="57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6CC61F81-6DBF-437C-AB04-400E920A7A46}"/>
                </a:ext>
              </a:extLst>
            </p:cNvPr>
            <p:cNvGrpSpPr/>
            <p:nvPr/>
          </p:nvGrpSpPr>
          <p:grpSpPr>
            <a:xfrm>
              <a:off x="1847926" y="1273184"/>
              <a:ext cx="757067" cy="276999"/>
              <a:chOff x="1122619" y="5394686"/>
              <a:chExt cx="757067" cy="276997"/>
            </a:xfrm>
          </p:grpSpPr>
          <p:sp>
            <p:nvSpPr>
              <p:cNvPr id="8" name="ZoneTexte 7">
                <a:extLst>
                  <a:ext uri="{FF2B5EF4-FFF2-40B4-BE49-F238E27FC236}">
                    <a16:creationId xmlns:a16="http://schemas.microsoft.com/office/drawing/2014/main" id="{B3E13CED-BDB3-4C35-A5CD-ACF8684562CB}"/>
                  </a:ext>
                </a:extLst>
              </p:cNvPr>
              <p:cNvSpPr txBox="1"/>
              <p:nvPr/>
            </p:nvSpPr>
            <p:spPr>
              <a:xfrm>
                <a:off x="1122619" y="5394686"/>
                <a:ext cx="757067" cy="276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Veliparib</a:t>
                </a:r>
              </a:p>
            </p:txBody>
          </p:sp>
          <p:cxnSp>
            <p:nvCxnSpPr>
              <p:cNvPr id="9" name="Connecteur droit 8">
                <a:extLst>
                  <a:ext uri="{FF2B5EF4-FFF2-40B4-BE49-F238E27FC236}">
                    <a16:creationId xmlns:a16="http://schemas.microsoft.com/office/drawing/2014/main" id="{0DBE8B86-1FDF-4F32-9C46-FA9152350F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3294" y="5614953"/>
                <a:ext cx="57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1FDBB48E-31BB-4A01-B3BC-5646099E1DF0}"/>
                </a:ext>
              </a:extLst>
            </p:cNvPr>
            <p:cNvSpPr txBox="1"/>
            <p:nvPr/>
          </p:nvSpPr>
          <p:spPr>
            <a:xfrm>
              <a:off x="1143591" y="1530193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05A30CC0-63B9-4A6D-9677-8A68662B32E2}"/>
                </a:ext>
              </a:extLst>
            </p:cNvPr>
            <p:cNvSpPr txBox="1"/>
            <p:nvPr/>
          </p:nvSpPr>
          <p:spPr>
            <a:xfrm>
              <a:off x="1505993" y="1519475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+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8FBE9A41-AC33-46F8-BC99-51C2FDEF4603}"/>
                </a:ext>
              </a:extLst>
            </p:cNvPr>
            <p:cNvSpPr txBox="1"/>
            <p:nvPr/>
          </p:nvSpPr>
          <p:spPr>
            <a:xfrm>
              <a:off x="1906381" y="1521226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AC4A2170-BDEB-4CF6-A3FB-551349FB199F}"/>
                </a:ext>
              </a:extLst>
            </p:cNvPr>
            <p:cNvSpPr txBox="1"/>
            <p:nvPr/>
          </p:nvSpPr>
          <p:spPr>
            <a:xfrm>
              <a:off x="2268783" y="151050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+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7D1ACF77-8E03-4BD8-98AF-4A0C106772E1}"/>
                </a:ext>
              </a:extLst>
            </p:cNvPr>
            <p:cNvSpPr txBox="1"/>
            <p:nvPr/>
          </p:nvSpPr>
          <p:spPr>
            <a:xfrm>
              <a:off x="595308" y="1562709"/>
              <a:ext cx="4892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H</a:t>
              </a:r>
              <a:r>
                <a:rPr lang="en-GB" sz="1200" b="1" baseline="-25000" dirty="0"/>
                <a:t>2</a:t>
              </a:r>
              <a:r>
                <a:rPr lang="en-GB" sz="1200" b="1" dirty="0"/>
                <a:t>O</a:t>
              </a:r>
              <a:r>
                <a:rPr lang="en-GB" sz="1200" b="1" baseline="-25000" dirty="0"/>
                <a:t>2</a:t>
              </a:r>
            </a:p>
          </p:txBody>
        </p:sp>
      </p:grpSp>
      <p:grpSp>
        <p:nvGrpSpPr>
          <p:cNvPr id="16" name="Groupe 15">
            <a:extLst>
              <a:ext uri="{FF2B5EF4-FFF2-40B4-BE49-F238E27FC236}">
                <a16:creationId xmlns:a16="http://schemas.microsoft.com/office/drawing/2014/main" id="{19F4310E-26BA-4A69-A6DA-91294A696586}"/>
              </a:ext>
            </a:extLst>
          </p:cNvPr>
          <p:cNvGrpSpPr/>
          <p:nvPr/>
        </p:nvGrpSpPr>
        <p:grpSpPr>
          <a:xfrm>
            <a:off x="3429000" y="5749934"/>
            <a:ext cx="2009685" cy="626341"/>
            <a:chOff x="595308" y="1273184"/>
            <a:chExt cx="2009685" cy="626341"/>
          </a:xfrm>
        </p:grpSpPr>
        <p:grpSp>
          <p:nvGrpSpPr>
            <p:cNvPr id="17" name="Groupe 16">
              <a:extLst>
                <a:ext uri="{FF2B5EF4-FFF2-40B4-BE49-F238E27FC236}">
                  <a16:creationId xmlns:a16="http://schemas.microsoft.com/office/drawing/2014/main" id="{8A0DA907-1060-4B85-B812-F7750DE92F7B}"/>
                </a:ext>
              </a:extLst>
            </p:cNvPr>
            <p:cNvGrpSpPr/>
            <p:nvPr/>
          </p:nvGrpSpPr>
          <p:grpSpPr>
            <a:xfrm>
              <a:off x="949652" y="1285710"/>
              <a:ext cx="966740" cy="276999"/>
              <a:chOff x="1074491" y="5394686"/>
              <a:chExt cx="966740" cy="276997"/>
            </a:xfrm>
          </p:grpSpPr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BA6EE3DE-BB50-4789-BCC0-37C19420CD7B}"/>
                  </a:ext>
                </a:extLst>
              </p:cNvPr>
              <p:cNvSpPr txBox="1"/>
              <p:nvPr/>
            </p:nvSpPr>
            <p:spPr>
              <a:xfrm>
                <a:off x="1074491" y="5394686"/>
                <a:ext cx="966740" cy="276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Non-treated</a:t>
                </a:r>
              </a:p>
            </p:txBody>
          </p:sp>
          <p:cxnSp>
            <p:nvCxnSpPr>
              <p:cNvPr id="27" name="Connecteur droit 26">
                <a:extLst>
                  <a:ext uri="{FF2B5EF4-FFF2-40B4-BE49-F238E27FC236}">
                    <a16:creationId xmlns:a16="http://schemas.microsoft.com/office/drawing/2014/main" id="{51B4FE4E-1523-480E-A076-740B58CC5A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3294" y="5614953"/>
                <a:ext cx="57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e 17">
              <a:extLst>
                <a:ext uri="{FF2B5EF4-FFF2-40B4-BE49-F238E27FC236}">
                  <a16:creationId xmlns:a16="http://schemas.microsoft.com/office/drawing/2014/main" id="{A35CA07C-48C9-433B-9339-B4C682134D80}"/>
                </a:ext>
              </a:extLst>
            </p:cNvPr>
            <p:cNvGrpSpPr/>
            <p:nvPr/>
          </p:nvGrpSpPr>
          <p:grpSpPr>
            <a:xfrm>
              <a:off x="1847926" y="1273184"/>
              <a:ext cx="757067" cy="276999"/>
              <a:chOff x="1122619" y="5394686"/>
              <a:chExt cx="757067" cy="276997"/>
            </a:xfrm>
          </p:grpSpPr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95B98E74-3CEE-40FD-B6F1-A415D31CA5FB}"/>
                  </a:ext>
                </a:extLst>
              </p:cNvPr>
              <p:cNvSpPr txBox="1"/>
              <p:nvPr/>
            </p:nvSpPr>
            <p:spPr>
              <a:xfrm>
                <a:off x="1122619" y="5394686"/>
                <a:ext cx="757067" cy="276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Veliparib</a:t>
                </a:r>
              </a:p>
            </p:txBody>
          </p:sp>
          <p:cxnSp>
            <p:nvCxnSpPr>
              <p:cNvPr id="25" name="Connecteur droit 24">
                <a:extLst>
                  <a:ext uri="{FF2B5EF4-FFF2-40B4-BE49-F238E27FC236}">
                    <a16:creationId xmlns:a16="http://schemas.microsoft.com/office/drawing/2014/main" id="{FBCF7861-D3B4-435A-A9F9-805B95C6C6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3294" y="5614953"/>
                <a:ext cx="57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251279B8-B0FA-4044-9416-3BFB2EEF9326}"/>
                </a:ext>
              </a:extLst>
            </p:cNvPr>
            <p:cNvSpPr txBox="1"/>
            <p:nvPr/>
          </p:nvSpPr>
          <p:spPr>
            <a:xfrm>
              <a:off x="1143591" y="1530193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F13D1ECD-7228-4D64-AD6D-E35C5A95DAD8}"/>
                </a:ext>
              </a:extLst>
            </p:cNvPr>
            <p:cNvSpPr txBox="1"/>
            <p:nvPr/>
          </p:nvSpPr>
          <p:spPr>
            <a:xfrm>
              <a:off x="1505993" y="1519475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+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56BA83BE-4CEA-4CF6-91F5-065F2B399A93}"/>
                </a:ext>
              </a:extLst>
            </p:cNvPr>
            <p:cNvSpPr txBox="1"/>
            <p:nvPr/>
          </p:nvSpPr>
          <p:spPr>
            <a:xfrm>
              <a:off x="1906381" y="1521226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1D250535-9294-488F-9B34-CD9036A6DC08}"/>
                </a:ext>
              </a:extLst>
            </p:cNvPr>
            <p:cNvSpPr txBox="1"/>
            <p:nvPr/>
          </p:nvSpPr>
          <p:spPr>
            <a:xfrm>
              <a:off x="2268783" y="151050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+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9E6496FE-55F2-4D70-A7BE-93440C0442D8}"/>
                </a:ext>
              </a:extLst>
            </p:cNvPr>
            <p:cNvSpPr txBox="1"/>
            <p:nvPr/>
          </p:nvSpPr>
          <p:spPr>
            <a:xfrm>
              <a:off x="595308" y="1562709"/>
              <a:ext cx="4892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H</a:t>
              </a:r>
              <a:r>
                <a:rPr lang="en-GB" sz="1200" b="1" baseline="-25000" dirty="0"/>
                <a:t>2</a:t>
              </a:r>
              <a:r>
                <a:rPr lang="en-GB" sz="1200" b="1" dirty="0"/>
                <a:t>O</a:t>
              </a:r>
              <a:r>
                <a:rPr lang="en-GB" sz="1200" b="1" baseline="-25000" dirty="0"/>
                <a:t>2</a:t>
              </a:r>
            </a:p>
          </p:txBody>
        </p:sp>
      </p:grpSp>
      <p:sp>
        <p:nvSpPr>
          <p:cNvPr id="28" name="Rectangle 27">
            <a:extLst>
              <a:ext uri="{FF2B5EF4-FFF2-40B4-BE49-F238E27FC236}">
                <a16:creationId xmlns:a16="http://schemas.microsoft.com/office/drawing/2014/main" id="{B8D6530E-1CA6-48DD-9301-37530A3513DE}"/>
              </a:ext>
            </a:extLst>
          </p:cNvPr>
          <p:cNvSpPr/>
          <p:nvPr/>
        </p:nvSpPr>
        <p:spPr>
          <a:xfrm>
            <a:off x="4117576" y="40727"/>
            <a:ext cx="285941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7 – Figure supplement 4 – source data xx</a:t>
            </a:r>
            <a:endParaRPr lang="fr-FR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35211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M03090430[[fn=À bandes]]</Template>
  <TotalTime>33481</TotalTime>
  <Words>58</Words>
  <Application>Microsoft Office PowerPoint</Application>
  <PresentationFormat>Format A4 (210 x 297 mm)</PresentationFormat>
  <Paragraphs>31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rinne Abbadie</dc:creator>
  <cp:lastModifiedBy>erwan goy</cp:lastModifiedBy>
  <cp:revision>886</cp:revision>
  <cp:lastPrinted>2020-05-29T13:23:39Z</cp:lastPrinted>
  <dcterms:created xsi:type="dcterms:W3CDTF">2016-03-17T09:30:03Z</dcterms:created>
  <dcterms:modified xsi:type="dcterms:W3CDTF">2021-10-29T13:21:47Z</dcterms:modified>
</cp:coreProperties>
</file>